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9" r:id="rId3"/>
    <p:sldId id="270" r:id="rId4"/>
    <p:sldId id="268" r:id="rId5"/>
    <p:sldId id="283" r:id="rId6"/>
    <p:sldId id="284" r:id="rId7"/>
    <p:sldId id="285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3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2" y="2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A5B42A-6B97-4B2A-91BC-96E93785F2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0ECBDAA-FD7B-4962-9345-5960D23017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B4CFB5C-2639-4D7D-A1A9-B974245D4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C85C426-A23C-487F-A2FD-C4965B5C4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88A044F-ED2D-4325-8D49-B5D221FC3A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3174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E09F39-CCE3-4F32-92C6-35B13C75B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126504E-8203-4901-BB9B-4A433EA0F4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18B4006-9242-449B-895C-6BA1A8C2C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BBE97BA-8C2A-405F-824D-1E38D55B3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11842D3-C37B-4E70-AAAE-5CB07CD23C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697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98F9470-8BB3-4355-8843-7B5F8140AC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8C69B27-6E80-4672-8B99-20D9BF2A8E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204E36A-D961-4AB5-A622-F32E8EFD7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5D9E9E1-D85E-413E-A94D-408F85F8B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EE776B8-EF3F-4B31-B7F7-2D2FAFDEB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660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FD12571-1211-49A9-9E74-03C8FCA04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B84DFF2-4FF7-4368-A621-7B411C91B5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0E4295B-A406-43F5-83E0-CA562CD63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75AF4A0-18CE-4039-95CE-D6355EC36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3A50640-FB80-4924-827E-5057F83D8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1082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D8D05C-5364-4141-8273-5009C7E9E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5FB3FA2-4BB2-4AA8-89F6-496C9E06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4522525-2FBF-4BF8-83E3-3970136BF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CB9468-1C4E-4A17-8860-881CC3370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8739044-FA9D-48BA-BED7-627173594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1204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2FE24B-C7B0-4530-9081-B431933F9E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33686D8-F5A3-4A88-A963-97E9FDA29D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2D0BC6D-C723-4BFC-B21C-7B51A613C1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050A87F-6B88-4EDD-A7D4-4CDDE0C27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2356037-349B-4FAA-8D34-09BC3523D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0713514-0A4C-44FD-8481-2D2F442D3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2794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D6BE188-ECD6-4C60-A626-FD50130C7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FBDCEFF-CBDA-49C8-AF7C-398842AF6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913BA49-CB74-4D5A-80E1-968D6799D2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EA08F14-0614-4D3E-A773-C27A51EC12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ACB4884E-AC92-4BD6-B4E2-F90159AFC9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6ADDDA5-F1F4-4159-AE3C-2106D5E47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4B7F2F5-F0D5-48D5-A108-AB577C3D1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E5DCA5E-7F54-4DC8-B187-3304F5C53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3384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4072DBF-C881-4643-9790-607DF5DEE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1CD6941-76A9-4901-AAF5-21E711E30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B363B71A-9DAD-4E80-A315-C8984A00B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44EDF3C-E03B-4A69-B0CD-C6E646717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0935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2216552-208B-4252-8883-40BE62EBE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2C4895E6-B928-4065-AC4B-58C587606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F0B8635-BC34-4ED7-8B3A-723072889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244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CA9083B-A15A-4178-9429-CBE5A70B8B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C710D00-56D3-460C-A255-934444989B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3EB470B-6CA2-4C22-B5FC-F49E4F734D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07C0E9D-A5A0-46F1-9004-6D2042AA4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AE6858D-F28C-43F3-8D5A-37BAB16CFC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510922B-957C-4B13-BEBB-632C7C64E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0767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57DA18E-8874-45A6-91E2-6E3B03A121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DB3FAAE-5B1F-4F14-A13F-E1C8035BC6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0C56563-3C8A-4745-B4F6-537F96BDF4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1882F8C-4660-417D-9BA1-360630AAC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D1FBF98-B075-4645-A45A-44D81A09B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078D2D9-00FB-40D6-8DE6-C356CE8D1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3100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188DAB7-4815-4A62-A418-C71D991218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3C54390-19FD-4132-AC65-FD0900B461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9BC3A27-AC05-496B-9687-AF5FB9482F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44536-F79C-49E6-936F-C5C1281A01CC}" type="datetimeFigureOut">
              <a:rPr lang="de-DE" smtClean="0"/>
              <a:t>13.02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AD72117-3F1F-406F-91A4-B43049DEFC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8CD4A75-DA79-472F-8537-5F0D153DEF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A12E1-D87B-4691-95FE-F532D7C38E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6650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E53618-2A14-4B80-BA28-09EAC167D87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olved HBV infection is not associated with liver-related outcomes after </a:t>
            </a:r>
            <a:r>
              <a:rPr lang="en-GB" sz="1800" b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CV cure – </a:t>
            </a: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from the German Hepatitis C-Registry</a:t>
            </a:r>
            <a:b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de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9E2C4E1-9F78-4A67-999F-42D03F4B7E9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Figures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978780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id="{D72ACBBD-46F8-9AC9-82A2-01C52A57AE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595" y="275839"/>
            <a:ext cx="5972810" cy="351663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676818D8-6AC4-4B59-BE4F-84AA85149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br>
              <a:rPr lang="de-DE" dirty="0"/>
            </a:br>
            <a:r>
              <a:rPr lang="de-DE" dirty="0"/>
              <a:t>Figure 1 </a:t>
            </a:r>
          </a:p>
        </p:txBody>
      </p:sp>
      <p:sp>
        <p:nvSpPr>
          <p:cNvPr id="11" name="Textfeld 22">
            <a:extLst>
              <a:ext uri="{FF2B5EF4-FFF2-40B4-BE49-F238E27FC236}">
                <a16:creationId xmlns:a16="http://schemas.microsoft.com/office/drawing/2014/main" id="{B2EB649F-2FFC-4CBB-AD1A-BA2B5C07A7A3}"/>
              </a:ext>
            </a:extLst>
          </p:cNvPr>
          <p:cNvSpPr txBox="1"/>
          <p:nvPr/>
        </p:nvSpPr>
        <p:spPr>
          <a:xfrm>
            <a:off x="4284271" y="3433000"/>
            <a:ext cx="5010785" cy="297815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LRE including HCC (p = 0.536; years after 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EoT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)</a:t>
            </a:r>
          </a:p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MS Mincho" panose="02020609040205080304" pitchFamily="49" charset="-128"/>
              <a:cs typeface="Courier New" panose="02070309020205020404" pitchFamily="49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2D62A808-C6F7-28CA-C426-0E9869E30B9D}"/>
              </a:ext>
            </a:extLst>
          </p:cNvPr>
          <p:cNvSpPr txBox="1"/>
          <p:nvPr/>
        </p:nvSpPr>
        <p:spPr>
          <a:xfrm>
            <a:off x="2348691" y="5079091"/>
            <a:ext cx="8881944" cy="1751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: KPK liver-related events including de novo-HCC Overall Cohort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erman Hepatitis C Registry. HB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olog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ker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selin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es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i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dictiv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gar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Kaplan-Meier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urve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monstrat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at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-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clu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v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egative and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ositiv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ti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VR after HC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fectio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h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ti-HBs positive versus negativ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bbreviation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HCC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LRE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o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end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atmen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patiti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rfac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ge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;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body to hepatitis B core antigen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2" name="Tabelle 11">
            <a:extLst>
              <a:ext uri="{FF2B5EF4-FFF2-40B4-BE49-F238E27FC236}">
                <a16:creationId xmlns:a16="http://schemas.microsoft.com/office/drawing/2014/main" id="{6FAD7CD1-FFC6-9E36-715B-94F8FAF85D4D}"/>
              </a:ext>
            </a:extLst>
          </p:cNvPr>
          <p:cNvGraphicFramePr>
            <a:graphicFrameLocks noGrp="1"/>
          </p:cNvGraphicFramePr>
          <p:nvPr/>
        </p:nvGraphicFramePr>
        <p:xfrm>
          <a:off x="3753751" y="4045780"/>
          <a:ext cx="4160838" cy="745492"/>
        </p:xfrm>
        <a:graphic>
          <a:graphicData uri="http://schemas.openxmlformats.org/drawingml/2006/table">
            <a:tbl>
              <a:tblPr firstRow="1" firstCol="1" bandRow="1"/>
              <a:tblGrid>
                <a:gridCol w="846138">
                  <a:extLst>
                    <a:ext uri="{9D8B030D-6E8A-4147-A177-3AD203B41FA5}">
                      <a16:colId xmlns:a16="http://schemas.microsoft.com/office/drawing/2014/main" val="3479378098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1062920920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3559380640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1152635922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394180914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155938589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2206998217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1000937895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37913317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Year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0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4314587"/>
                  </a:ext>
                </a:extLst>
              </a:tr>
              <a:tr h="385827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+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0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5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3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7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01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9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42834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-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1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7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0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4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02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9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5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1068757"/>
                  </a:ext>
                </a:extLst>
              </a:tr>
            </a:tbl>
          </a:graphicData>
        </a:graphic>
      </p:graphicFrame>
      <p:sp>
        <p:nvSpPr>
          <p:cNvPr id="14" name="Textfeld 13">
            <a:extLst>
              <a:ext uri="{FF2B5EF4-FFF2-40B4-BE49-F238E27FC236}">
                <a16:creationId xmlns:a16="http://schemas.microsoft.com/office/drawing/2014/main" id="{6DCB1A6F-EA6E-57E6-B886-D91C22C5F1EF}"/>
              </a:ext>
            </a:extLst>
          </p:cNvPr>
          <p:cNvSpPr txBox="1"/>
          <p:nvPr/>
        </p:nvSpPr>
        <p:spPr>
          <a:xfrm>
            <a:off x="3657599" y="3803708"/>
            <a:ext cx="9669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umber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t </a:t>
            </a: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isk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821453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D126AC66-5671-0ADF-7AD8-D038B1A81A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595" y="334365"/>
            <a:ext cx="5972810" cy="351663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D641C766-AEB7-4FAB-9ADC-2FF877ABE9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br>
              <a:rPr lang="de-DE" dirty="0"/>
            </a:br>
            <a:r>
              <a:rPr lang="de-DE" dirty="0"/>
              <a:t>Figure 2</a:t>
            </a:r>
          </a:p>
        </p:txBody>
      </p:sp>
      <p:sp>
        <p:nvSpPr>
          <p:cNvPr id="7" name="Textfeld 26">
            <a:extLst>
              <a:ext uri="{FF2B5EF4-FFF2-40B4-BE49-F238E27FC236}">
                <a16:creationId xmlns:a16="http://schemas.microsoft.com/office/drawing/2014/main" id="{42BD1C98-CFC9-486C-953E-A5976D18252F}"/>
              </a:ext>
            </a:extLst>
          </p:cNvPr>
          <p:cNvSpPr txBox="1"/>
          <p:nvPr/>
        </p:nvSpPr>
        <p:spPr>
          <a:xfrm>
            <a:off x="4084771" y="3566136"/>
            <a:ext cx="5010785" cy="297815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LRE excluding HCC (p = 0.513; years after 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EoT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)</a:t>
            </a:r>
          </a:p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MS Mincho" panose="02020609040205080304" pitchFamily="49" charset="-128"/>
              <a:cs typeface="Courier New" panose="02070309020205020404" pitchFamily="49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A374C486-C289-B5A4-A5AA-1DD80C19917D}"/>
              </a:ext>
            </a:extLst>
          </p:cNvPr>
          <p:cNvSpPr txBox="1"/>
          <p:nvPr/>
        </p:nvSpPr>
        <p:spPr>
          <a:xfrm>
            <a:off x="1361947" y="5123274"/>
            <a:ext cx="9468106" cy="1751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2: KPK liver-related events excluding de novo-HCC Overall Cohort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erman Hepatitis C Registry. HB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olog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ker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selin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es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i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dictiv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gar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Kaplan-Meier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urve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monstrat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at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-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v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egative and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ositiv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ti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VR after HC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fectio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h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ti-HBs positive versus negativ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bbreviation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HCC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LRE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o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end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atmen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patiti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rfac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ge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;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body to hepatitis B core antigen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0" name="Tabelle 9">
            <a:extLst>
              <a:ext uri="{FF2B5EF4-FFF2-40B4-BE49-F238E27FC236}">
                <a16:creationId xmlns:a16="http://schemas.microsoft.com/office/drawing/2014/main" id="{21D43FCC-AE12-8BBD-C2D3-0A9FB511BE9F}"/>
              </a:ext>
            </a:extLst>
          </p:cNvPr>
          <p:cNvGraphicFramePr>
            <a:graphicFrameLocks noGrp="1"/>
          </p:cNvGraphicFramePr>
          <p:nvPr/>
        </p:nvGraphicFramePr>
        <p:xfrm>
          <a:off x="3425643" y="4094241"/>
          <a:ext cx="4282963" cy="540958"/>
        </p:xfrm>
        <a:graphic>
          <a:graphicData uri="http://schemas.openxmlformats.org/drawingml/2006/table">
            <a:tbl>
              <a:tblPr firstRow="1" firstCol="1" bandRow="1"/>
              <a:tblGrid>
                <a:gridCol w="836014">
                  <a:extLst>
                    <a:ext uri="{9D8B030D-6E8A-4147-A177-3AD203B41FA5}">
                      <a16:colId xmlns:a16="http://schemas.microsoft.com/office/drawing/2014/main" val="1028124065"/>
                    </a:ext>
                  </a:extLst>
                </a:gridCol>
                <a:gridCol w="432908">
                  <a:extLst>
                    <a:ext uri="{9D8B030D-6E8A-4147-A177-3AD203B41FA5}">
                      <a16:colId xmlns:a16="http://schemas.microsoft.com/office/drawing/2014/main" val="947740038"/>
                    </a:ext>
                  </a:extLst>
                </a:gridCol>
                <a:gridCol w="441064">
                  <a:extLst>
                    <a:ext uri="{9D8B030D-6E8A-4147-A177-3AD203B41FA5}">
                      <a16:colId xmlns:a16="http://schemas.microsoft.com/office/drawing/2014/main" val="972087139"/>
                    </a:ext>
                  </a:extLst>
                </a:gridCol>
                <a:gridCol w="432908">
                  <a:extLst>
                    <a:ext uri="{9D8B030D-6E8A-4147-A177-3AD203B41FA5}">
                      <a16:colId xmlns:a16="http://schemas.microsoft.com/office/drawing/2014/main" val="453219691"/>
                    </a:ext>
                  </a:extLst>
                </a:gridCol>
                <a:gridCol w="432908">
                  <a:extLst>
                    <a:ext uri="{9D8B030D-6E8A-4147-A177-3AD203B41FA5}">
                      <a16:colId xmlns:a16="http://schemas.microsoft.com/office/drawing/2014/main" val="4153382663"/>
                    </a:ext>
                  </a:extLst>
                </a:gridCol>
                <a:gridCol w="432908">
                  <a:extLst>
                    <a:ext uri="{9D8B030D-6E8A-4147-A177-3AD203B41FA5}">
                      <a16:colId xmlns:a16="http://schemas.microsoft.com/office/drawing/2014/main" val="2870101111"/>
                    </a:ext>
                  </a:extLst>
                </a:gridCol>
                <a:gridCol w="370167">
                  <a:extLst>
                    <a:ext uri="{9D8B030D-6E8A-4147-A177-3AD203B41FA5}">
                      <a16:colId xmlns:a16="http://schemas.microsoft.com/office/drawing/2014/main" val="3218109596"/>
                    </a:ext>
                  </a:extLst>
                </a:gridCol>
                <a:gridCol w="370167">
                  <a:extLst>
                    <a:ext uri="{9D8B030D-6E8A-4147-A177-3AD203B41FA5}">
                      <a16:colId xmlns:a16="http://schemas.microsoft.com/office/drawing/2014/main" val="1348064650"/>
                    </a:ext>
                  </a:extLst>
                </a:gridCol>
                <a:gridCol w="533919">
                  <a:extLst>
                    <a:ext uri="{9D8B030D-6E8A-4147-A177-3AD203B41FA5}">
                      <a16:colId xmlns:a16="http://schemas.microsoft.com/office/drawing/2014/main" val="241985968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Year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0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352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+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0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5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3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77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0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0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15402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-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1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70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0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4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0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6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6637239"/>
                  </a:ext>
                </a:extLst>
              </a:tr>
            </a:tbl>
          </a:graphicData>
        </a:graphic>
      </p:graphicFrame>
      <p:sp>
        <p:nvSpPr>
          <p:cNvPr id="11" name="Textfeld 10">
            <a:extLst>
              <a:ext uri="{FF2B5EF4-FFF2-40B4-BE49-F238E27FC236}">
                <a16:creationId xmlns:a16="http://schemas.microsoft.com/office/drawing/2014/main" id="{92F26166-F65F-235A-CDEA-7941BCB2C35F}"/>
              </a:ext>
            </a:extLst>
          </p:cNvPr>
          <p:cNvSpPr txBox="1"/>
          <p:nvPr/>
        </p:nvSpPr>
        <p:spPr>
          <a:xfrm>
            <a:off x="3327990" y="3850453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umber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t </a:t>
            </a: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isk</a:t>
            </a:r>
            <a:endParaRPr kumimoji="0" lang="de-DE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27406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Grafik 11">
            <a:extLst>
              <a:ext uri="{FF2B5EF4-FFF2-40B4-BE49-F238E27FC236}">
                <a16:creationId xmlns:a16="http://schemas.microsoft.com/office/drawing/2014/main" id="{15BF3650-F1A3-41AB-09E3-A94D31A05F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9594" y="262694"/>
            <a:ext cx="5972810" cy="351663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247E0084-FAEF-4DA9-A0AA-EF35F36B4E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br>
              <a:rPr lang="de-DE" dirty="0"/>
            </a:br>
            <a:r>
              <a:rPr lang="de-DE" dirty="0"/>
              <a:t>Figure 3</a:t>
            </a:r>
          </a:p>
        </p:txBody>
      </p:sp>
      <p:sp>
        <p:nvSpPr>
          <p:cNvPr id="8" name="Textfeld 29">
            <a:extLst>
              <a:ext uri="{FF2B5EF4-FFF2-40B4-BE49-F238E27FC236}">
                <a16:creationId xmlns:a16="http://schemas.microsoft.com/office/drawing/2014/main" id="{FCFB9498-3C9F-4414-BB2B-908F9D7D255C}"/>
              </a:ext>
            </a:extLst>
          </p:cNvPr>
          <p:cNvSpPr txBox="1"/>
          <p:nvPr/>
        </p:nvSpPr>
        <p:spPr>
          <a:xfrm>
            <a:off x="4211122" y="3486064"/>
            <a:ext cx="5010785" cy="297815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De novo HCC (p = 0.997; years after 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EoT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)</a:t>
            </a:r>
          </a:p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MS Mincho" panose="02020609040205080304" pitchFamily="49" charset="-128"/>
              <a:cs typeface="Courier New" panose="02070309020205020404" pitchFamily="49" charset="0"/>
            </a:endParaRP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96DB350B-5C42-99C8-5DDE-ABD08742F844}"/>
              </a:ext>
            </a:extLst>
          </p:cNvPr>
          <p:cNvSpPr txBox="1"/>
          <p:nvPr/>
        </p:nvSpPr>
        <p:spPr>
          <a:xfrm>
            <a:off x="2307993" y="5082454"/>
            <a:ext cx="7576011" cy="19210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3: KPK de novo-HCC Overall Cohort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erman Hepatitis C Registry. HB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olog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ker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selin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es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i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dictiv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gar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Kaplan-Meier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urve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monstrat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at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-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v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egative and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ositiv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ti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VR after HC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fectio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h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ti-HBs positive versus negativ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bbreviation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HCC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LRE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o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end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atmen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patiti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rfac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ge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;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body to hepatitis B core antigen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3" name="Tabelle 12">
            <a:extLst>
              <a:ext uri="{FF2B5EF4-FFF2-40B4-BE49-F238E27FC236}">
                <a16:creationId xmlns:a16="http://schemas.microsoft.com/office/drawing/2014/main" id="{7AC0EB81-E4A3-1BDE-FDAB-4F0E8969C32E}"/>
              </a:ext>
            </a:extLst>
          </p:cNvPr>
          <p:cNvGraphicFramePr>
            <a:graphicFrameLocks noGrp="1"/>
          </p:cNvGraphicFramePr>
          <p:nvPr/>
        </p:nvGraphicFramePr>
        <p:xfrm>
          <a:off x="3546335" y="4042591"/>
          <a:ext cx="4334828" cy="540958"/>
        </p:xfrm>
        <a:graphic>
          <a:graphicData uri="http://schemas.openxmlformats.org/drawingml/2006/table">
            <a:tbl>
              <a:tblPr firstRow="1" firstCol="1" bandRow="1"/>
              <a:tblGrid>
                <a:gridCol w="846138">
                  <a:extLst>
                    <a:ext uri="{9D8B030D-6E8A-4147-A177-3AD203B41FA5}">
                      <a16:colId xmlns:a16="http://schemas.microsoft.com/office/drawing/2014/main" val="1036715673"/>
                    </a:ext>
                  </a:extLst>
                </a:gridCol>
                <a:gridCol w="446405">
                  <a:extLst>
                    <a:ext uri="{9D8B030D-6E8A-4147-A177-3AD203B41FA5}">
                      <a16:colId xmlns:a16="http://schemas.microsoft.com/office/drawing/2014/main" val="3867236398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2225318543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865132730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1440174742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3210234008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2795212568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3619731561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32178244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Year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743967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+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0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58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3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77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0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1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0556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-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1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7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0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46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0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5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02141186"/>
                  </a:ext>
                </a:extLst>
              </a:tr>
            </a:tbl>
          </a:graphicData>
        </a:graphic>
      </p:graphicFrame>
      <p:sp>
        <p:nvSpPr>
          <p:cNvPr id="14" name="Textfeld 13">
            <a:extLst>
              <a:ext uri="{FF2B5EF4-FFF2-40B4-BE49-F238E27FC236}">
                <a16:creationId xmlns:a16="http://schemas.microsoft.com/office/drawing/2014/main" id="{BE40A622-DE9C-6559-FF3F-BFE2650672AD}"/>
              </a:ext>
            </a:extLst>
          </p:cNvPr>
          <p:cNvSpPr txBox="1"/>
          <p:nvPr/>
        </p:nvSpPr>
        <p:spPr>
          <a:xfrm>
            <a:off x="3455580" y="3793264"/>
            <a:ext cx="9669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umber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t </a:t>
            </a: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isk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6645099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A5A84CC1-E85E-564A-A990-652C5EAA58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8959" y="308178"/>
            <a:ext cx="5974080" cy="351663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676818D8-6AC4-4B59-BE4F-84AA85149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br>
              <a:rPr lang="de-DE" dirty="0"/>
            </a:br>
            <a:r>
              <a:rPr lang="de-DE" dirty="0"/>
              <a:t>Figure 4</a:t>
            </a:r>
          </a:p>
        </p:txBody>
      </p:sp>
      <p:sp>
        <p:nvSpPr>
          <p:cNvPr id="11" name="Textfeld 22">
            <a:extLst>
              <a:ext uri="{FF2B5EF4-FFF2-40B4-BE49-F238E27FC236}">
                <a16:creationId xmlns:a16="http://schemas.microsoft.com/office/drawing/2014/main" id="{B2EB649F-2FFC-4CBB-AD1A-BA2B5C07A7A3}"/>
              </a:ext>
            </a:extLst>
          </p:cNvPr>
          <p:cNvSpPr txBox="1"/>
          <p:nvPr/>
        </p:nvSpPr>
        <p:spPr>
          <a:xfrm>
            <a:off x="4072254" y="3539871"/>
            <a:ext cx="5010785" cy="297815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LRE including HCC (p = 0.324; years after 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EoT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)</a:t>
            </a:r>
          </a:p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MS Mincho" panose="02020609040205080304" pitchFamily="49" charset="-128"/>
              <a:cs typeface="Courier New" panose="02070309020205020404" pitchFamily="49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2D62A808-C6F7-28CA-C426-0E9869E30B9D}"/>
              </a:ext>
            </a:extLst>
          </p:cNvPr>
          <p:cNvSpPr txBox="1"/>
          <p:nvPr/>
        </p:nvSpPr>
        <p:spPr>
          <a:xfrm>
            <a:off x="1655027" y="5106238"/>
            <a:ext cx="8881944" cy="1751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4: KPK liver-related events including de novo-HCC Cirrhosis Subgroup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erman Hepatitis C Registry. HB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olog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ker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selin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es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i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dictiv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gar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Kaplan-Meier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urve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monstrat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at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-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v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egative and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ositiv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ti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VR after HC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fectio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h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ti-HBs positive versus negativ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bbreviation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HCC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LRE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o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end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atmen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patiti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rfac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ge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;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body to hepatitis B core antigen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6DCB1A6F-EA6E-57E6-B886-D91C22C5F1EF}"/>
              </a:ext>
            </a:extLst>
          </p:cNvPr>
          <p:cNvSpPr txBox="1"/>
          <p:nvPr/>
        </p:nvSpPr>
        <p:spPr>
          <a:xfrm>
            <a:off x="3498111" y="3844594"/>
            <a:ext cx="9669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umber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t </a:t>
            </a: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isk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287BEA26-6673-B573-9531-123DCD364B8E}"/>
              </a:ext>
            </a:extLst>
          </p:cNvPr>
          <p:cNvGraphicFramePr>
            <a:graphicFrameLocks noGrp="1"/>
          </p:cNvGraphicFramePr>
          <p:nvPr/>
        </p:nvGraphicFramePr>
        <p:xfrm>
          <a:off x="3599496" y="4095213"/>
          <a:ext cx="4136073" cy="540958"/>
        </p:xfrm>
        <a:graphic>
          <a:graphicData uri="http://schemas.openxmlformats.org/drawingml/2006/table">
            <a:tbl>
              <a:tblPr firstRow="1" firstCol="1" bandRow="1"/>
              <a:tblGrid>
                <a:gridCol w="846138">
                  <a:extLst>
                    <a:ext uri="{9D8B030D-6E8A-4147-A177-3AD203B41FA5}">
                      <a16:colId xmlns:a16="http://schemas.microsoft.com/office/drawing/2014/main" val="2505927731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1107194250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4014800469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3650052437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3425607459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649372723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1723153369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994765099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225207917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Year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15836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+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57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37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94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3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9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18655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-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4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29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98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9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4900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452320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A6408860-114A-7A96-FCCA-6F76CBDB5D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4563" y="300035"/>
            <a:ext cx="5974080" cy="351663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D641C766-AEB7-4FAB-9ADC-2FF877ABE9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br>
              <a:rPr lang="de-DE" dirty="0"/>
            </a:br>
            <a:r>
              <a:rPr lang="de-DE" dirty="0"/>
              <a:t>Figure 5</a:t>
            </a:r>
          </a:p>
        </p:txBody>
      </p:sp>
      <p:sp>
        <p:nvSpPr>
          <p:cNvPr id="7" name="Textfeld 26">
            <a:extLst>
              <a:ext uri="{FF2B5EF4-FFF2-40B4-BE49-F238E27FC236}">
                <a16:creationId xmlns:a16="http://schemas.microsoft.com/office/drawing/2014/main" id="{42BD1C98-CFC9-486C-953E-A5976D18252F}"/>
              </a:ext>
            </a:extLst>
          </p:cNvPr>
          <p:cNvSpPr txBox="1"/>
          <p:nvPr/>
        </p:nvSpPr>
        <p:spPr>
          <a:xfrm>
            <a:off x="4147858" y="3518850"/>
            <a:ext cx="5010785" cy="297815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LRE excluding HCC (p = 0.359; years after 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EoT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)</a:t>
            </a:r>
          </a:p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MS Mincho" panose="02020609040205080304" pitchFamily="49" charset="-128"/>
              <a:cs typeface="Courier New" panose="02070309020205020404" pitchFamily="49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A374C486-C289-B5A4-A5AA-1DD80C19917D}"/>
              </a:ext>
            </a:extLst>
          </p:cNvPr>
          <p:cNvSpPr txBox="1"/>
          <p:nvPr/>
        </p:nvSpPr>
        <p:spPr>
          <a:xfrm>
            <a:off x="1361947" y="4974418"/>
            <a:ext cx="9468106" cy="1751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5: KPK liver-related events excluding de novo-HCC Cirrhosis Subgroup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erman Hepatitis C Registry. HB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olog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ker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selin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es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i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dictiv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gar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Kaplan-Meier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urve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monstrat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at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-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v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egative and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ositiv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ti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VR after HC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fectio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h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ti-HBs positive versus negativ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bbreviation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HCC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LRE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o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end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atmen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patiti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rfac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ge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;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body to hepatitis B core antigen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92F26166-F65F-235A-CDEA-7941BCB2C35F}"/>
              </a:ext>
            </a:extLst>
          </p:cNvPr>
          <p:cNvSpPr txBox="1"/>
          <p:nvPr/>
        </p:nvSpPr>
        <p:spPr>
          <a:xfrm>
            <a:off x="3455580" y="3757845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umber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t </a:t>
            </a: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isk</a:t>
            </a:r>
            <a:endParaRPr kumimoji="0" lang="de-DE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A1BCA15E-35C6-260A-C705-4F6CA4A2A38A}"/>
              </a:ext>
            </a:extLst>
          </p:cNvPr>
          <p:cNvGraphicFramePr>
            <a:graphicFrameLocks noGrp="1"/>
          </p:cNvGraphicFramePr>
          <p:nvPr/>
        </p:nvGraphicFramePr>
        <p:xfrm>
          <a:off x="3546332" y="3988677"/>
          <a:ext cx="4136073" cy="540958"/>
        </p:xfrm>
        <a:graphic>
          <a:graphicData uri="http://schemas.openxmlformats.org/drawingml/2006/table">
            <a:tbl>
              <a:tblPr firstRow="1" firstCol="1" bandRow="1"/>
              <a:tblGrid>
                <a:gridCol w="846138">
                  <a:extLst>
                    <a:ext uri="{9D8B030D-6E8A-4147-A177-3AD203B41FA5}">
                      <a16:colId xmlns:a16="http://schemas.microsoft.com/office/drawing/2014/main" val="1908300815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844752818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3552934173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2553786607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3250252490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2022919179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694175259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962847339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376847147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Year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63371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+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5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38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9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7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28032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-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4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29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99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7109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059365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1149112E-5AD4-67EC-FC71-A8831D94E4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8958" y="248063"/>
            <a:ext cx="5974080" cy="351663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itel 1">
            <a:extLst>
              <a:ext uri="{FF2B5EF4-FFF2-40B4-BE49-F238E27FC236}">
                <a16:creationId xmlns:a16="http://schemas.microsoft.com/office/drawing/2014/main" id="{247E0084-FAEF-4DA9-A0AA-EF35F36B4E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-1717"/>
            <a:ext cx="10515600" cy="1325563"/>
          </a:xfrm>
        </p:spPr>
        <p:txBody>
          <a:bodyPr/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br>
              <a:rPr lang="de-DE" dirty="0"/>
            </a:br>
            <a:r>
              <a:rPr lang="de-DE" dirty="0"/>
              <a:t>Figure 6 </a:t>
            </a:r>
          </a:p>
        </p:txBody>
      </p:sp>
      <p:sp>
        <p:nvSpPr>
          <p:cNvPr id="8" name="Textfeld 29">
            <a:extLst>
              <a:ext uri="{FF2B5EF4-FFF2-40B4-BE49-F238E27FC236}">
                <a16:creationId xmlns:a16="http://schemas.microsoft.com/office/drawing/2014/main" id="{FCFB9498-3C9F-4414-BB2B-908F9D7D255C}"/>
              </a:ext>
            </a:extLst>
          </p:cNvPr>
          <p:cNvSpPr txBox="1"/>
          <p:nvPr/>
        </p:nvSpPr>
        <p:spPr>
          <a:xfrm>
            <a:off x="4221754" y="3466878"/>
            <a:ext cx="5010785" cy="297815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De novo HCC (p = 0.536; years after </a:t>
            </a:r>
            <a:r>
              <a:rPr kumimoji="0" lang="en-US" sz="1000" b="1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EoT</a:t>
            </a:r>
            <a:r>
              <a:rPr kumimoji="0" lang="en-US" sz="10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Courier New" panose="02070309020205020404" pitchFamily="49" charset="0"/>
              </a:rPr>
              <a:t>)</a:t>
            </a:r>
          </a:p>
          <a:p>
            <a:pPr marL="39370" marR="39370" lvl="0" indent="0" algn="l" defTabSz="914400" rtl="0" eaLnBrk="1" fontAlgn="auto" latinLnBrk="0" hangingPunct="1">
              <a:lnSpc>
                <a:spcPts val="16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MS Mincho" panose="02020609040205080304" pitchFamily="49" charset="-128"/>
              <a:cs typeface="Courier New" panose="02070309020205020404" pitchFamily="49" charset="0"/>
            </a:endParaRP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96DB350B-5C42-99C8-5DDE-ABD08742F844}"/>
              </a:ext>
            </a:extLst>
          </p:cNvPr>
          <p:cNvSpPr txBox="1"/>
          <p:nvPr/>
        </p:nvSpPr>
        <p:spPr>
          <a:xfrm>
            <a:off x="2307992" y="4936961"/>
            <a:ext cx="7576011" cy="19210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6: KPK de novo-HCC Cirrhosis Subgroup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erman Hepatitis C Registry. HB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olog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arker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t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aselin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es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i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edictiv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alu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gar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linical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dpoi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Kaplan-Meier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urve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monstrat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rat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-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cludin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d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v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egative and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ositive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ti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ith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VR after HCV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fectio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ho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r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ti-HBs positive versus negative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bbreviation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HCC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patocellula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rcinoma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LRE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iver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lated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vent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o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end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f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atment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;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BsAG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patitis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rface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gen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; Anti-</a:t>
            </a:r>
            <a:r>
              <a:rPr kumimoji="0" lang="de-DE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Bc</a:t>
            </a:r>
            <a:r>
              <a:rPr kumimoji="0" lang="de-DE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: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ntibody to hepatitis B core antigen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BE40A622-DE9C-6559-FF3F-BFE2650672AD}"/>
              </a:ext>
            </a:extLst>
          </p:cNvPr>
          <p:cNvSpPr txBox="1"/>
          <p:nvPr/>
        </p:nvSpPr>
        <p:spPr>
          <a:xfrm>
            <a:off x="3438670" y="3764693"/>
            <a:ext cx="9669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umber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t </a:t>
            </a: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risk</a:t>
            </a: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224C61F9-0D31-C5C2-B6FD-465EF15A752D}"/>
              </a:ext>
            </a:extLst>
          </p:cNvPr>
          <p:cNvGraphicFramePr>
            <a:graphicFrameLocks noGrp="1"/>
          </p:cNvGraphicFramePr>
          <p:nvPr/>
        </p:nvGraphicFramePr>
        <p:xfrm>
          <a:off x="3545640" y="4014473"/>
          <a:ext cx="4136073" cy="540958"/>
        </p:xfrm>
        <a:graphic>
          <a:graphicData uri="http://schemas.openxmlformats.org/drawingml/2006/table">
            <a:tbl>
              <a:tblPr firstRow="1" firstCol="1" bandRow="1"/>
              <a:tblGrid>
                <a:gridCol w="846138">
                  <a:extLst>
                    <a:ext uri="{9D8B030D-6E8A-4147-A177-3AD203B41FA5}">
                      <a16:colId xmlns:a16="http://schemas.microsoft.com/office/drawing/2014/main" val="621148134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62715118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val="1796826665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3591339608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2485390413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1069030199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3151505251"/>
                    </a:ext>
                  </a:extLst>
                </a:gridCol>
                <a:gridCol w="374650">
                  <a:extLst>
                    <a:ext uri="{9D8B030D-6E8A-4147-A177-3AD203B41FA5}">
                      <a16:colId xmlns:a16="http://schemas.microsoft.com/office/drawing/2014/main" val="2017786757"/>
                    </a:ext>
                  </a:extLst>
                </a:gridCol>
                <a:gridCol w="540385">
                  <a:extLst>
                    <a:ext uri="{9D8B030D-6E8A-4147-A177-3AD203B41FA5}">
                      <a16:colId xmlns:a16="http://schemas.microsoft.com/office/drawing/2014/main" val="61654639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Year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14824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+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5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38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9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5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4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1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27768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39370" marR="39370">
                        <a:lnSpc>
                          <a:spcPts val="1600"/>
                        </a:lnSpc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Anti-HBs</a:t>
                      </a: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 -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4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128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99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7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0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36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27</a:t>
                      </a:r>
                      <a:endParaRPr lang="de-DE" sz="1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39370" marR="39370" algn="ctr">
                        <a:lnSpc>
                          <a:spcPts val="1600"/>
                        </a:lnSpc>
                      </a:pPr>
                      <a:r>
                        <a:rPr lang="en-GB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MS Mincho" panose="02020609040205080304" pitchFamily="49" charset="-128"/>
                          <a:cs typeface="Courier New" panose="02070309020205020404" pitchFamily="49" charset="0"/>
                        </a:rPr>
                        <a:t>6</a:t>
                      </a:r>
                      <a:endParaRPr lang="de-DE" sz="1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Courier New" panose="02070309020205020404" pitchFamily="49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64032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627485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1</Words>
  <Application>Microsoft Office PowerPoint</Application>
  <PresentationFormat>Breitbild</PresentationFormat>
  <Paragraphs>200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1_Office</vt:lpstr>
      <vt:lpstr>Resolved HBV infection is not associated with liver-related outcomes after HCV cure – Data from the German Hepatitis C-Registry  </vt:lpstr>
      <vt:lpstr>Supplementary Figure 1 </vt:lpstr>
      <vt:lpstr>Supplementary  Figure 2</vt:lpstr>
      <vt:lpstr>Supplementary  Figure 3</vt:lpstr>
      <vt:lpstr>Supplementary  Figure 4</vt:lpstr>
      <vt:lpstr>Supplementary  Figure 5</vt:lpstr>
      <vt:lpstr>Supplementary  Figure 6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ilhelm, Laura Muana Dr.</dc:creator>
  <cp:lastModifiedBy>Wilhelm, Laura Muana Dr.</cp:lastModifiedBy>
  <cp:revision>8</cp:revision>
  <dcterms:created xsi:type="dcterms:W3CDTF">2025-09-09T10:32:10Z</dcterms:created>
  <dcterms:modified xsi:type="dcterms:W3CDTF">2026-02-13T16:46:40Z</dcterms:modified>
</cp:coreProperties>
</file>